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9"/>
  </p:notesMasterIdLst>
  <p:sldIdLst>
    <p:sldId id="1228" r:id="rId5"/>
    <p:sldId id="1230" r:id="rId6"/>
    <p:sldId id="1231" r:id="rId7"/>
    <p:sldId id="1232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19" d="100"/>
          <a:sy n="119" d="100"/>
        </p:scale>
        <p:origin x="96" y="3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DD20E1B-3E64-4E44-8E49-771258E87053}" type="datetimeFigureOut">
              <a:rPr lang="en-US" smtClean="0"/>
              <a:t>3/28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DD803F5-E5D3-4D41-8AC7-7FC948925D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14990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C9EE49-38D6-4E55-82F7-0167DA0C4FA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319DFFE-AD1F-40C0-AE24-AD5E52DA0F6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494976-3F0B-4E8B-8208-0E05F5583B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3/2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26FF56-B30B-4E03-A0E4-3A44DDFDF5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A31D69-ADC9-448D-999F-3322C02556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73611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3560A6-1B23-4BAD-85C3-20AF840C9D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F558710-DB8E-4B76-900E-595AB1C895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077492-9C61-4150-A5E4-A1ACC8BDDC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3/2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20ADCE-6EC7-4A66-A5CE-1574F8B090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B5F701-6737-4975-9050-EF10DFE687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28092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6DC2CCA-2153-406F-B620-5165AEBCC6B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3EA2FEB-2DD2-4DF4-B55A-69851717A4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964BF9-AAC9-44A1-B686-917DCEDF6A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3/2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F5B741-C2B1-4C38-ABCA-0707FD7AE1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A7CB9F-D05B-47D7-8862-CD2E787C4A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96241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BFED64-2978-4906-971A-0C30B02464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B3486F9-899E-4E61-BD97-00ECEA97BEE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52D7A3-0FB1-4765-804A-66A8CD25CC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3/2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7A84A8-C772-4AA9-AD01-E4AB5E2754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134F50-803E-4A34-9CE4-DFCAF4917F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07793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C27402-B6F7-496F-9168-737333FB02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5218033-8254-4069-A7C3-367390B1A7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108C8F-4BE8-412C-A5C5-EBF0743467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3/2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21C04F-E6BA-469A-B8A0-A7F7F6641B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93E45A-275D-4789-9B8A-0F165DE520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97124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5BD979-90E3-4D18-BF7F-584E3FE4F8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0B7C3F-E181-4C40-8551-57491701F9E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EC314BF-C22E-46FE-99B4-16FF3FD9B6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F87D311-995D-4A96-AB63-E246BBCCC1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3/28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968B2F-F9D9-4A88-9113-0113B4A6C0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1834612-BC87-4D48-8EF7-F0E896E1AB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8768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78746D-DB48-45D1-9E4A-BFF87B4906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20E256F-32F3-4CD7-8D03-BCB2B75A09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02CBC4C-EAF8-4999-8F86-357FE86F46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BC4B1A6-8ECE-4BA8-9F3D-207BF2A0550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E3FEF7C-628D-4BFC-A986-E51785C46DD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0E1C663-F600-4659-8A62-31B9D22A92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3/28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91394FD-434B-49A0-B7B7-E5AA6D654B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0F5F51C-A0EF-4A23-91F9-55D0687D5F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78442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1B70E8-54D0-46F9-B69A-CDAFD1DF9D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2BE95E5-0977-4EFC-B4E9-74BF587A30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3/28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5D426E2-1E29-4EEB-B2C2-122B010545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B9FAE89-106F-45F7-8FF8-437163202C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5200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00ECE79-EC41-4291-93C3-122193AE11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3/28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91EA767-D8CC-4F85-A306-4379B4E555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0FA106E-C4B7-45FC-B960-8FCD9053D9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63081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6D90AD-5063-4E1A-9CD1-9C4D1529DC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5E132BB-7071-45B8-9D4A-8F5AD9A2855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59F5E45-BB35-4CFA-A6C8-3879F4B44E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6F475A2-95D4-45B0-8357-3AB34898EE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3/28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2DB3094-A30E-4D54-BCCD-1D870ABC17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0854AE6-B70E-4D9B-9AF0-1D674B6CFF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45466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872D05-1D5F-4C20-A961-91D041AB31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4208714-59FB-404D-855E-91D7E443924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30433D4-7F52-498A-954C-405ACAB40F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9AE6348-C8B5-4AE2-9EB8-6B87D54429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3/28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1DE4293-4006-4FC5-87A0-6301775360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6E6827B-260C-48EA-9024-BD0F7D727E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61033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68C8844-0AC5-4BD7-82C8-8EACC64535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18825C4-D291-41F3-88AD-8D43FE4FF2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3E45E1-238E-4E7E-8866-BF6B70B73D9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EEDC51-7057-4F86-864E-02967C951E54}" type="datetimeFigureOut">
              <a:rPr lang="en-US" smtClean="0"/>
              <a:t>3/2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8B1C0D-B282-4F21-A9FE-AFBFCF95EA4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9A37CF-3812-472A-B598-2DB8F67CC6A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59805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6A89889-7BF7-444A-9663-47011429483E}"/>
              </a:ext>
            </a:extLst>
          </p:cNvPr>
          <p:cNvSpPr txBox="1"/>
          <p:nvPr/>
        </p:nvSpPr>
        <p:spPr>
          <a:xfrm>
            <a:off x="344904" y="1548063"/>
            <a:ext cx="11662611" cy="313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: Distribution of log</a:t>
            </a:r>
            <a:r>
              <a:rPr lang="en-US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R) values for H1-true and H2-true tests of two, three, and four person mixtures by software and mixture ratios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plots shown are distributions of log</a:t>
            </a:r>
            <a:r>
              <a:rPr lang="en-US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Rs) as function of NOC, software, propositions, and mixture ratios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og</a:t>
            </a:r>
            <a:r>
              <a:rPr lang="en-US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R) values obtained in STRmix (shown in magenta) and EFM (shown in blue) when two, three, and four person mixtures were compared to known contributors (H1-true or sensitivity test). Log</a:t>
            </a:r>
            <a:r>
              <a:rPr lang="en-US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R) values obtained in STRmix (shown in cyan) and EFM (shown in green) when two, three, and four person mixtures were compared to known non-donors (H2-true or specificity test). The central horizontal line at log</a:t>
            </a:r>
            <a:r>
              <a:rPr lang="en-US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R) = 0 represents neutrality. LR results of 0 are plotted at </a:t>
            </a:r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−125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 the log</a:t>
            </a:r>
            <a:r>
              <a:rPr lang="en-US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scale. </a:t>
            </a:r>
          </a:p>
          <a:p>
            <a:pPr algn="just"/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 Two H1-true test interpretations of 2P mixtures for which STRmix assigned profile LRs of 0 (plotted in magenta at ratio mixture of 1:4 in the NOC = 2 Person distribution plot) at −125 on the log</a:t>
            </a:r>
            <a:r>
              <a:rPr lang="en-US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scale and discussed in detail in Section 3.6. </a:t>
            </a:r>
          </a:p>
          <a:p>
            <a:pPr algn="just"/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246747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D7B75F16-F4D3-4561-A06B-9105FF103878}"/>
              </a:ext>
            </a:extLst>
          </p:cNvPr>
          <p:cNvSpPr txBox="1"/>
          <p:nvPr/>
        </p:nvSpPr>
        <p:spPr>
          <a:xfrm>
            <a:off x="-41007" y="-67065"/>
            <a:ext cx="120382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</a:t>
            </a:r>
            <a:r>
              <a:rPr lang="en-US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R) Distribution by Software &amp; Mixture Ratios for 2 Person Mixtures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36E7242C-1EFC-482D-806C-C88B7913C5E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79838" y="333045"/>
            <a:ext cx="6396511" cy="6400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13607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0F71B40-BDED-47EF-9592-0E375676423C}"/>
              </a:ext>
            </a:extLst>
          </p:cNvPr>
          <p:cNvSpPr txBox="1"/>
          <p:nvPr/>
        </p:nvSpPr>
        <p:spPr>
          <a:xfrm>
            <a:off x="0" y="-72190"/>
            <a:ext cx="120382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</a:t>
            </a:r>
            <a:r>
              <a:rPr lang="en-US" sz="2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R) Distribution by Software &amp; Mixture Ratios for 3 Person Mixtures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7F1E6C5-D7BC-4E08-AF8A-580A32CF0DC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17005" y="392935"/>
            <a:ext cx="6404191" cy="6400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041951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D3A5C35-68BD-42BC-AD1E-95BD3BD20DFD}"/>
              </a:ext>
            </a:extLst>
          </p:cNvPr>
          <p:cNvSpPr txBox="1"/>
          <p:nvPr/>
        </p:nvSpPr>
        <p:spPr>
          <a:xfrm>
            <a:off x="-41007" y="-67065"/>
            <a:ext cx="120382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</a:t>
            </a:r>
            <a:r>
              <a:rPr lang="en-US" sz="2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R) Distribution by Software &amp; Mixture Ratios for 4 Person Mixtures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464385A-CB3B-44AC-B2F6-F2AD43F3768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75998" y="333045"/>
            <a:ext cx="6404191" cy="6400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10659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B73957F21AE394984F7C14244486252" ma:contentTypeVersion="2" ma:contentTypeDescription="Create a new document." ma:contentTypeScope="" ma:versionID="9257d4b4774658276c24bca62ab9b61a">
  <xsd:schema xmlns:xsd="http://www.w3.org/2001/XMLSchema" xmlns:xs="http://www.w3.org/2001/XMLSchema" xmlns:p="http://schemas.microsoft.com/office/2006/metadata/properties" xmlns:ns3="16def918-8aa6-4d32-a507-8df69469fc9f" targetNamespace="http://schemas.microsoft.com/office/2006/metadata/properties" ma:root="true" ma:fieldsID="c0dcced12536570fcf1c8b537cc77aa8" ns3:_="">
    <xsd:import namespace="16def918-8aa6-4d32-a507-8df69469fc9f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6def918-8aa6-4d32-a507-8df69469fc9f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5F16B353-2DC5-4BB0-A6B3-D39996901A59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7A3058CB-D426-4C55-884F-5BC024168D36}">
  <ds:schemaRefs>
    <ds:schemaRef ds:uri="http://purl.org/dc/dcmitype/"/>
    <ds:schemaRef ds:uri="http://schemas.microsoft.com/office/infopath/2007/PartnerControls"/>
    <ds:schemaRef ds:uri="http://schemas.microsoft.com/office/2006/documentManagement/types"/>
    <ds:schemaRef ds:uri="16def918-8aa6-4d32-a507-8df69469fc9f"/>
    <ds:schemaRef ds:uri="http://purl.org/dc/elements/1.1/"/>
    <ds:schemaRef ds:uri="http://schemas.microsoft.com/office/2006/metadata/properties"/>
    <ds:schemaRef ds:uri="http://purl.org/dc/terms/"/>
    <ds:schemaRef ds:uri="http://schemas.openxmlformats.org/package/2006/metadata/core-properties"/>
    <ds:schemaRef ds:uri="http://www.w3.org/XML/1998/namespace"/>
  </ds:schemaRefs>
</ds:datastoreItem>
</file>

<file path=customXml/itemProps3.xml><?xml version="1.0" encoding="utf-8"?>
<ds:datastoreItem xmlns:ds="http://schemas.openxmlformats.org/officeDocument/2006/customXml" ds:itemID="{4C7A3457-0DE0-4961-9965-5A36BBE12E44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6def918-8aa6-4d32-a507-8df69469fc9f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56</TotalTime>
  <Words>254</Words>
  <Application>Microsoft Office PowerPoint</Application>
  <PresentationFormat>Widescreen</PresentationFormat>
  <Paragraphs>7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iman, Sarah (Assoc)</dc:creator>
  <cp:lastModifiedBy>Riman, Sarah (Assoc)</cp:lastModifiedBy>
  <cp:revision>60</cp:revision>
  <dcterms:created xsi:type="dcterms:W3CDTF">2020-09-07T01:57:31Z</dcterms:created>
  <dcterms:modified xsi:type="dcterms:W3CDTF">2021-03-28T19:17:2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B73957F21AE394984F7C14244486252</vt:lpwstr>
  </property>
</Properties>
</file>